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66" r:id="rId2"/>
    <p:sldId id="267" r:id="rId3"/>
    <p:sldId id="268" r:id="rId4"/>
    <p:sldId id="270" r:id="rId5"/>
    <p:sldId id="264" r:id="rId6"/>
    <p:sldId id="269" r:id="rId7"/>
  </p:sldIdLst>
  <p:sldSz cx="6858000" cy="9907588"/>
  <p:notesSz cx="9671050" cy="68897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E9982C-388A-4E6C-BEFC-6F9339BCBF1F}" v="8" dt="2022-03-09T15:08:28.9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125"/>
    <p:restoredTop sz="96405"/>
  </p:normalViewPr>
  <p:slideViewPr>
    <p:cSldViewPr snapToGrid="0" snapToObjects="1">
      <p:cViewPr>
        <p:scale>
          <a:sx n="120" d="100"/>
          <a:sy n="120" d="100"/>
        </p:scale>
        <p:origin x="3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aham Packham" userId="2fcda275-3dea-4c92-a4cb-7d58419967f9" providerId="ADAL" clId="{FE6BC69A-0232-44A5-B6BA-392C4AF1106D}"/>
    <pc:docChg chg="modSld">
      <pc:chgData name="Graham Packham" userId="2fcda275-3dea-4c92-a4cb-7d58419967f9" providerId="ADAL" clId="{FE6BC69A-0232-44A5-B6BA-392C4AF1106D}" dt="2022-02-06T13:46:30.956" v="1" actId="20577"/>
      <pc:docMkLst>
        <pc:docMk/>
      </pc:docMkLst>
      <pc:sldChg chg="modSp mod">
        <pc:chgData name="Graham Packham" userId="2fcda275-3dea-4c92-a4cb-7d58419967f9" providerId="ADAL" clId="{FE6BC69A-0232-44A5-B6BA-392C4AF1106D}" dt="2022-02-06T13:46:22.442" v="0" actId="20577"/>
        <pc:sldMkLst>
          <pc:docMk/>
          <pc:sldMk cId="3540660311" sldId="268"/>
        </pc:sldMkLst>
        <pc:spChg chg="mod">
          <ac:chgData name="Graham Packham" userId="2fcda275-3dea-4c92-a4cb-7d58419967f9" providerId="ADAL" clId="{FE6BC69A-0232-44A5-B6BA-392C4AF1106D}" dt="2022-02-06T13:46:22.442" v="0" actId="20577"/>
          <ac:spMkLst>
            <pc:docMk/>
            <pc:sldMk cId="3540660311" sldId="268"/>
            <ac:spMk id="4" creationId="{7E11CD2A-3078-4BD3-AF12-C9F7EF975BAF}"/>
          </ac:spMkLst>
        </pc:spChg>
      </pc:sldChg>
      <pc:sldChg chg="modSp mod">
        <pc:chgData name="Graham Packham" userId="2fcda275-3dea-4c92-a4cb-7d58419967f9" providerId="ADAL" clId="{FE6BC69A-0232-44A5-B6BA-392C4AF1106D}" dt="2022-02-06T13:46:30.956" v="1" actId="20577"/>
        <pc:sldMkLst>
          <pc:docMk/>
          <pc:sldMk cId="1010328870" sldId="269"/>
        </pc:sldMkLst>
        <pc:spChg chg="mod">
          <ac:chgData name="Graham Packham" userId="2fcda275-3dea-4c92-a4cb-7d58419967f9" providerId="ADAL" clId="{FE6BC69A-0232-44A5-B6BA-392C4AF1106D}" dt="2022-02-06T13:46:30.956" v="1" actId="20577"/>
          <ac:spMkLst>
            <pc:docMk/>
            <pc:sldMk cId="1010328870" sldId="269"/>
            <ac:spMk id="3" creationId="{FC2CEDF0-DFCA-4930-BE2E-22B693EAEE61}"/>
          </ac:spMkLst>
        </pc:spChg>
      </pc:sldChg>
    </pc:docChg>
  </pc:docChgLst>
  <pc:docChgLst>
    <pc:chgData name="Graham Packham" userId="2fcda275-3dea-4c92-a4cb-7d58419967f9" providerId="ADAL" clId="{2EE9982C-388A-4E6C-BEFC-6F9339BCBF1F}"/>
    <pc:docChg chg="undo custSel addSld modSld">
      <pc:chgData name="Graham Packham" userId="2fcda275-3dea-4c92-a4cb-7d58419967f9" providerId="ADAL" clId="{2EE9982C-388A-4E6C-BEFC-6F9339BCBF1F}" dt="2022-03-09T15:08:20.168" v="518" actId="1076"/>
      <pc:docMkLst>
        <pc:docMk/>
      </pc:docMkLst>
      <pc:sldChg chg="addSp delSp modSp mod">
        <pc:chgData name="Graham Packham" userId="2fcda275-3dea-4c92-a4cb-7d58419967f9" providerId="ADAL" clId="{2EE9982C-388A-4E6C-BEFC-6F9339BCBF1F}" dt="2022-03-09T15:08:20.168" v="518" actId="1076"/>
        <pc:sldMkLst>
          <pc:docMk/>
          <pc:sldMk cId="3540660311" sldId="268"/>
        </pc:sldMkLst>
        <pc:spChg chg="mod">
          <ac:chgData name="Graham Packham" userId="2fcda275-3dea-4c92-a4cb-7d58419967f9" providerId="ADAL" clId="{2EE9982C-388A-4E6C-BEFC-6F9339BCBF1F}" dt="2022-03-09T15:07:36.253" v="508" actId="6549"/>
          <ac:spMkLst>
            <pc:docMk/>
            <pc:sldMk cId="3540660311" sldId="268"/>
            <ac:spMk id="4" creationId="{7E11CD2A-3078-4BD3-AF12-C9F7EF975BAF}"/>
          </ac:spMkLst>
        </pc:spChg>
        <pc:spChg chg="del">
          <ac:chgData name="Graham Packham" userId="2fcda275-3dea-4c92-a4cb-7d58419967f9" providerId="ADAL" clId="{2EE9982C-388A-4E6C-BEFC-6F9339BCBF1F}" dt="2022-03-09T15:05:06.585" v="63" actId="478"/>
          <ac:spMkLst>
            <pc:docMk/>
            <pc:sldMk cId="3540660311" sldId="268"/>
            <ac:spMk id="6" creationId="{6F64F3DC-EC89-46CB-A42E-D4460F46A727}"/>
          </ac:spMkLst>
        </pc:spChg>
        <pc:spChg chg="mod">
          <ac:chgData name="Graham Packham" userId="2fcda275-3dea-4c92-a4cb-7d58419967f9" providerId="ADAL" clId="{2EE9982C-388A-4E6C-BEFC-6F9339BCBF1F}" dt="2022-03-09T15:05:10.113" v="64" actId="1076"/>
          <ac:spMkLst>
            <pc:docMk/>
            <pc:sldMk cId="3540660311" sldId="268"/>
            <ac:spMk id="8" creationId="{4817D196-7105-4C6B-9656-5A260F71170B}"/>
          </ac:spMkLst>
        </pc:spChg>
        <pc:spChg chg="mod">
          <ac:chgData name="Graham Packham" userId="2fcda275-3dea-4c92-a4cb-7d58419967f9" providerId="ADAL" clId="{2EE9982C-388A-4E6C-BEFC-6F9339BCBF1F}" dt="2022-03-09T15:05:17.207" v="66" actId="1076"/>
          <ac:spMkLst>
            <pc:docMk/>
            <pc:sldMk cId="3540660311" sldId="268"/>
            <ac:spMk id="9" creationId="{F1D69955-EB48-443F-B436-08C95BC493D8}"/>
          </ac:spMkLst>
        </pc:spChg>
        <pc:spChg chg="add del">
          <ac:chgData name="Graham Packham" userId="2fcda275-3dea-4c92-a4cb-7d58419967f9" providerId="ADAL" clId="{2EE9982C-388A-4E6C-BEFC-6F9339BCBF1F}" dt="2022-03-09T15:07:52.059" v="510" actId="22"/>
          <ac:spMkLst>
            <pc:docMk/>
            <pc:sldMk cId="3540660311" sldId="268"/>
            <ac:spMk id="10" creationId="{1968E621-290B-47F8-8238-D2FA41C7AA72}"/>
          </ac:spMkLst>
        </pc:spChg>
        <pc:graphicFrameChg chg="mod">
          <ac:chgData name="Graham Packham" userId="2fcda275-3dea-4c92-a4cb-7d58419967f9" providerId="ADAL" clId="{2EE9982C-388A-4E6C-BEFC-6F9339BCBF1F}" dt="2022-03-09T15:05:12.303" v="65" actId="1076"/>
          <ac:graphicFrameMkLst>
            <pc:docMk/>
            <pc:sldMk cId="3540660311" sldId="268"/>
            <ac:graphicFrameMk id="2" creationId="{B375EA5C-78F9-49D1-9B48-111D935E9391}"/>
          </ac:graphicFrameMkLst>
        </pc:graphicFrameChg>
        <pc:graphicFrameChg chg="del">
          <ac:chgData name="Graham Packham" userId="2fcda275-3dea-4c92-a4cb-7d58419967f9" providerId="ADAL" clId="{2EE9982C-388A-4E6C-BEFC-6F9339BCBF1F}" dt="2022-03-09T15:05:06.585" v="63" actId="478"/>
          <ac:graphicFrameMkLst>
            <pc:docMk/>
            <pc:sldMk cId="3540660311" sldId="268"/>
            <ac:graphicFrameMk id="5" creationId="{707DC5E4-704A-4C90-A6A6-11BAC9BCFA9E}"/>
          </ac:graphicFrameMkLst>
        </pc:graphicFrameChg>
        <pc:graphicFrameChg chg="add mod">
          <ac:chgData name="Graham Packham" userId="2fcda275-3dea-4c92-a4cb-7d58419967f9" providerId="ADAL" clId="{2EE9982C-388A-4E6C-BEFC-6F9339BCBF1F}" dt="2022-03-09T15:08:20.168" v="518" actId="1076"/>
          <ac:graphicFrameMkLst>
            <pc:docMk/>
            <pc:sldMk cId="3540660311" sldId="268"/>
            <ac:graphicFrameMk id="11" creationId="{DD2E40B7-CF19-41B3-A2CF-6DBC5FC4EE2A}"/>
          </ac:graphicFrameMkLst>
        </pc:graphicFrameChg>
        <pc:picChg chg="del">
          <ac:chgData name="Graham Packham" userId="2fcda275-3dea-4c92-a4cb-7d58419967f9" providerId="ADAL" clId="{2EE9982C-388A-4E6C-BEFC-6F9339BCBF1F}" dt="2022-03-09T15:05:06.585" v="63" actId="478"/>
          <ac:picMkLst>
            <pc:docMk/>
            <pc:sldMk cId="3540660311" sldId="268"/>
            <ac:picMk id="7" creationId="{BB73125F-64B2-4FF2-B9BC-E5F7ABF0A577}"/>
          </ac:picMkLst>
        </pc:picChg>
      </pc:sldChg>
      <pc:sldChg chg="delSp modSp add mod">
        <pc:chgData name="Graham Packham" userId="2fcda275-3dea-4c92-a4cb-7d58419967f9" providerId="ADAL" clId="{2EE9982C-388A-4E6C-BEFC-6F9339BCBF1F}" dt="2022-03-09T15:05:00.419" v="62" actId="1035"/>
        <pc:sldMkLst>
          <pc:docMk/>
          <pc:sldMk cId="1186976717" sldId="270"/>
        </pc:sldMkLst>
        <pc:spChg chg="del">
          <ac:chgData name="Graham Packham" userId="2fcda275-3dea-4c92-a4cb-7d58419967f9" providerId="ADAL" clId="{2EE9982C-388A-4E6C-BEFC-6F9339BCBF1F}" dt="2022-03-09T15:04:52.015" v="1" actId="478"/>
          <ac:spMkLst>
            <pc:docMk/>
            <pc:sldMk cId="1186976717" sldId="270"/>
            <ac:spMk id="4" creationId="{7E11CD2A-3078-4BD3-AF12-C9F7EF975BAF}"/>
          </ac:spMkLst>
        </pc:spChg>
        <pc:spChg chg="mod">
          <ac:chgData name="Graham Packham" userId="2fcda275-3dea-4c92-a4cb-7d58419967f9" providerId="ADAL" clId="{2EE9982C-388A-4E6C-BEFC-6F9339BCBF1F}" dt="2022-03-09T15:05:00.419" v="62" actId="1035"/>
          <ac:spMkLst>
            <pc:docMk/>
            <pc:sldMk cId="1186976717" sldId="270"/>
            <ac:spMk id="6" creationId="{6F64F3DC-EC89-46CB-A42E-D4460F46A727}"/>
          </ac:spMkLst>
        </pc:spChg>
        <pc:spChg chg="mod">
          <ac:chgData name="Graham Packham" userId="2fcda275-3dea-4c92-a4cb-7d58419967f9" providerId="ADAL" clId="{2EE9982C-388A-4E6C-BEFC-6F9339BCBF1F}" dt="2022-03-09T15:05:00.419" v="62" actId="1035"/>
          <ac:spMkLst>
            <pc:docMk/>
            <pc:sldMk cId="1186976717" sldId="270"/>
            <ac:spMk id="8" creationId="{4817D196-7105-4C6B-9656-5A260F71170B}"/>
          </ac:spMkLst>
        </pc:spChg>
        <pc:spChg chg="mod">
          <ac:chgData name="Graham Packham" userId="2fcda275-3dea-4c92-a4cb-7d58419967f9" providerId="ADAL" clId="{2EE9982C-388A-4E6C-BEFC-6F9339BCBF1F}" dt="2022-03-09T15:05:00.419" v="62" actId="1035"/>
          <ac:spMkLst>
            <pc:docMk/>
            <pc:sldMk cId="1186976717" sldId="270"/>
            <ac:spMk id="9" creationId="{F1D69955-EB48-443F-B436-08C95BC493D8}"/>
          </ac:spMkLst>
        </pc:spChg>
        <pc:graphicFrameChg chg="del">
          <ac:chgData name="Graham Packham" userId="2fcda275-3dea-4c92-a4cb-7d58419967f9" providerId="ADAL" clId="{2EE9982C-388A-4E6C-BEFC-6F9339BCBF1F}" dt="2022-03-09T15:04:52.015" v="1" actId="478"/>
          <ac:graphicFrameMkLst>
            <pc:docMk/>
            <pc:sldMk cId="1186976717" sldId="270"/>
            <ac:graphicFrameMk id="2" creationId="{B375EA5C-78F9-49D1-9B48-111D935E9391}"/>
          </ac:graphicFrameMkLst>
        </pc:graphicFrameChg>
        <pc:graphicFrameChg chg="mod">
          <ac:chgData name="Graham Packham" userId="2fcda275-3dea-4c92-a4cb-7d58419967f9" providerId="ADAL" clId="{2EE9982C-388A-4E6C-BEFC-6F9339BCBF1F}" dt="2022-03-09T15:05:00.419" v="62" actId="1035"/>
          <ac:graphicFrameMkLst>
            <pc:docMk/>
            <pc:sldMk cId="1186976717" sldId="270"/>
            <ac:graphicFrameMk id="5" creationId="{707DC5E4-704A-4C90-A6A6-11BAC9BCFA9E}"/>
          </ac:graphicFrameMkLst>
        </pc:graphicFrameChg>
        <pc:picChg chg="mod">
          <ac:chgData name="Graham Packham" userId="2fcda275-3dea-4c92-a4cb-7d58419967f9" providerId="ADAL" clId="{2EE9982C-388A-4E6C-BEFC-6F9339BCBF1F}" dt="2022-03-09T15:05:00.419" v="62" actId="1035"/>
          <ac:picMkLst>
            <pc:docMk/>
            <pc:sldMk cId="1186976717" sldId="270"/>
            <ac:picMk id="7" creationId="{BB73125F-64B2-4FF2-B9BC-E5F7ABF0A57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824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4172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749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679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424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708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537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1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402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078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292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6AE6D-53CC-8642-ADEF-6EF9202ECB49}" type="datetimeFigureOut">
              <a:rPr lang="en-US" smtClean="0"/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F6439-5648-8F49-8231-312FC234F0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84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40DA555-BF1A-A14C-AE9C-BBABBE123DB2}"/>
              </a:ext>
            </a:extLst>
          </p:cNvPr>
          <p:cNvSpPr txBox="1"/>
          <p:nvPr/>
        </p:nvSpPr>
        <p:spPr>
          <a:xfrm>
            <a:off x="485383" y="2880172"/>
            <a:ext cx="5887233" cy="32692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le</a:t>
            </a:r>
          </a:p>
          <a:p>
            <a:pPr algn="ctr"/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cell receptor signaling induces proteasomal degradation of PDCD4 via MEK1/2 and mTORC1 in malignant B cells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Joe Taylor, Sarah Wilmore, Sophie Marriot, Karly-Rai Rogers-Broadway, Rachel Fell,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nabel R Minton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om Branch, Meg Ashton-Key, Mark Coldwell, Freda K Stevenson, Francesco Forconi, Andrew J Steele, Graham Packham and Alison Yeoman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12772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2353FEE5-4C43-304D-AC88-93AB975C0B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4168" y="7167283"/>
            <a:ext cx="5824002" cy="15292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Details of sampl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agnosis of CLL was according to the IWCLL-NCI 2008 criteria and the monoclonal B-cell population in the peripheral blood had a typical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gD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LL phenotype in all cases.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Wher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ffix is not shown, this is the first sample obtained from that patient, typically obtained shortly after diagnosis. A, B, C etc. indicate subsequent samples from the same patient.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IGHV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tation status (M, mutated; U, unmutated).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CLL cells.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xim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rcentage of cells with increased intracellular calcium following treatment with soluble anti-IgM.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luorescence intensity of IgM positive cells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not done.</a:t>
            </a:r>
            <a:endParaRPr lang="en-GB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B01D27C9-EF65-4FA8-9F24-4693C5F382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0981275"/>
              </p:ext>
            </p:extLst>
          </p:nvPr>
        </p:nvGraphicFramePr>
        <p:xfrm>
          <a:off x="1011584" y="1026373"/>
          <a:ext cx="4448175" cy="562979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889127">
                  <a:extLst>
                    <a:ext uri="{9D8B030D-6E8A-4147-A177-3AD203B41FA5}">
                      <a16:colId xmlns:a16="http://schemas.microsoft.com/office/drawing/2014/main" val="1320668546"/>
                    </a:ext>
                  </a:extLst>
                </a:gridCol>
                <a:gridCol w="889762">
                  <a:extLst>
                    <a:ext uri="{9D8B030D-6E8A-4147-A177-3AD203B41FA5}">
                      <a16:colId xmlns:a16="http://schemas.microsoft.com/office/drawing/2014/main" val="2252575881"/>
                    </a:ext>
                  </a:extLst>
                </a:gridCol>
                <a:gridCol w="889762">
                  <a:extLst>
                    <a:ext uri="{9D8B030D-6E8A-4147-A177-3AD203B41FA5}">
                      <a16:colId xmlns:a16="http://schemas.microsoft.com/office/drawing/2014/main" val="383583653"/>
                    </a:ext>
                  </a:extLst>
                </a:gridCol>
                <a:gridCol w="889762">
                  <a:extLst>
                    <a:ext uri="{9D8B030D-6E8A-4147-A177-3AD203B41FA5}">
                      <a16:colId xmlns:a16="http://schemas.microsoft.com/office/drawing/2014/main" val="3068834462"/>
                    </a:ext>
                  </a:extLst>
                </a:gridCol>
                <a:gridCol w="889762">
                  <a:extLst>
                    <a:ext uri="{9D8B030D-6E8A-4147-A177-3AD203B41FA5}">
                      <a16:colId xmlns:a16="http://schemas.microsoft.com/office/drawing/2014/main" val="1496659890"/>
                    </a:ext>
                  </a:extLst>
                </a:gridCol>
              </a:tblGrid>
              <a:tr h="176530">
                <a:tc>
                  <a:txBody>
                    <a:bodyPr/>
                    <a:lstStyle/>
                    <a:p>
                      <a:pPr algn="l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r>
                        <a:rPr lang="en-GB" sz="1050" b="1" kern="1200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1400" b="1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i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V</a:t>
                      </a: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050" b="1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us</a:t>
                      </a:r>
                      <a:r>
                        <a:rPr lang="en-GB" sz="1050" b="1" kern="1200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GB" sz="1400" b="1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L cells (%)</a:t>
                      </a:r>
                      <a:r>
                        <a:rPr lang="en-GB" sz="1050" b="1" kern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b="1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 signal capacity (%)</a:t>
                      </a:r>
                      <a:r>
                        <a:rPr lang="en-GB" sz="1050" b="1" kern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GB" sz="1400" b="1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M </a:t>
                      </a:r>
                    </a:p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</a:p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b="1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FI)</a:t>
                      </a:r>
                      <a:r>
                        <a:rPr lang="en-GB" sz="1050" b="1" kern="120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endParaRPr lang="en-GB" sz="1400" b="1" baseline="30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80057422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1C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21091625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3H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08977540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3F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00384425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3C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6624151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5B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58995928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5C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8287573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4G         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6887823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9C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77136872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1E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09206172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4B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91258612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4B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84189287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25812790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1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73714798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71471890"/>
                  </a:ext>
                </a:extLst>
              </a:tr>
              <a:tr h="176530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eaLnBrk="0" fontAlgn="base" hangingPunct="0">
                        <a:lnSpc>
                          <a:spcPct val="150000"/>
                        </a:lnSpc>
                      </a:pPr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94060977"/>
                  </a:ext>
                </a:extLst>
              </a:tr>
              <a:tr h="1911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7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4640302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4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9943407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82093739"/>
                  </a:ext>
                </a:extLst>
              </a:tr>
              <a:tr h="1911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B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86296044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3E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69180197"/>
                  </a:ext>
                </a:extLst>
              </a:tr>
              <a:tr h="1911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6E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39979147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6G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8665760"/>
                  </a:ext>
                </a:extLst>
              </a:tr>
              <a:tr h="2038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9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98326644"/>
                  </a:ext>
                </a:extLst>
              </a:tr>
              <a:tr h="191135">
                <a:tc>
                  <a:txBody>
                    <a:bodyPr/>
                    <a:lstStyle/>
                    <a:p>
                      <a:pPr algn="l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4  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GB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  <a:endParaRPr lang="en-GB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144529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467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E11CD2A-3078-4BD3-AF12-C9F7EF975BAF}"/>
              </a:ext>
            </a:extLst>
          </p:cNvPr>
          <p:cNvSpPr txBox="1"/>
          <p:nvPr/>
        </p:nvSpPr>
        <p:spPr>
          <a:xfrm>
            <a:off x="389731" y="3825696"/>
            <a:ext cx="6078538" cy="16633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</a:t>
            </a:r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.</a:t>
            </a: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effect of kinase inhibition on anti-IgM-induced PDCD4 down-regulation in CLL cells. (A)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hows the same data as presented in Fig. 4A of the main text, but with results for individual samples indicated (horizontal bar is mean). (B) Effect of SYK inhibition.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CLL samples (n=5) were pre-treated with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the indicated concentrations of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</a:rPr>
              <a:t>tamatinib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 or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MSO for 1 hour prior to treatment with anti-IgM or control antibody beads for 6 hours. Graph shows relative PDCD4 expression (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an±SD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with values for anti-IgM/DMSO-treated cells set to 1.0. The statistical significance compared to control cells is indicated (one sample t-tests)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375EA5C-78F9-49D1-9B48-111D935E93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9154418"/>
              </p:ext>
            </p:extLst>
          </p:nvPr>
        </p:nvGraphicFramePr>
        <p:xfrm>
          <a:off x="703880" y="733819"/>
          <a:ext cx="2638065" cy="29187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059713" imgH="3384728" progId="Prism9.Document">
                  <p:embed/>
                </p:oleObj>
              </mc:Choice>
              <mc:Fallback>
                <p:oleObj name="Prism 9" r:id="rId2" imgW="3059713" imgH="3384728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375EA5C-78F9-49D1-9B48-111D935E93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3880" y="733819"/>
                        <a:ext cx="2638065" cy="29187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817D196-7105-4C6B-9656-5A260F71170B}"/>
              </a:ext>
            </a:extLst>
          </p:cNvPr>
          <p:cNvSpPr txBox="1"/>
          <p:nvPr/>
        </p:nvSpPr>
        <p:spPr>
          <a:xfrm>
            <a:off x="305751" y="2187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D69955-EB48-443F-B436-08C95BC493D8}"/>
              </a:ext>
            </a:extLst>
          </p:cNvPr>
          <p:cNvSpPr txBox="1"/>
          <p:nvPr/>
        </p:nvSpPr>
        <p:spPr>
          <a:xfrm>
            <a:off x="3586194" y="2187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DD2E40B7-CF19-41B3-A2CF-6DBC5FC4EE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2280361"/>
              </p:ext>
            </p:extLst>
          </p:nvPr>
        </p:nvGraphicFramePr>
        <p:xfrm>
          <a:off x="3645517" y="498870"/>
          <a:ext cx="2278203" cy="30548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58882" imgH="3566245" progId="Prism9.Document">
                  <p:embed/>
                </p:oleObj>
              </mc:Choice>
              <mc:Fallback>
                <p:oleObj name="Prism 9" r:id="rId4" imgW="2658882" imgH="3566245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DD2E40B7-CF19-41B3-A2CF-6DBC5FC4EE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45517" y="498870"/>
                        <a:ext cx="2278203" cy="30548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406603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07DC5E4-704A-4C90-A6A6-11BAC9BCFA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9768957"/>
              </p:ext>
            </p:extLst>
          </p:nvPr>
        </p:nvGraphicFramePr>
        <p:xfrm>
          <a:off x="3558149" y="1352616"/>
          <a:ext cx="1970800" cy="2744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552282" imgH="3554000" progId="Prism9.Document">
                  <p:embed/>
                </p:oleObj>
              </mc:Choice>
              <mc:Fallback>
                <p:oleObj name="Prism 9" r:id="rId2" imgW="2552282" imgH="3554000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707DC5E4-704A-4C90-A6A6-11BAC9BCFA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8149" y="1352616"/>
                        <a:ext cx="1970800" cy="27441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F64F3DC-EC89-46CB-A42E-D4460F46A727}"/>
              </a:ext>
            </a:extLst>
          </p:cNvPr>
          <p:cNvSpPr txBox="1"/>
          <p:nvPr/>
        </p:nvSpPr>
        <p:spPr>
          <a:xfrm>
            <a:off x="369888" y="4262010"/>
            <a:ext cx="6050791" cy="14657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 2. 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PSI on anti-IgM-induced PDCD4 down-regulation in RAMOS cells. 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MOS cells were pre-treated with bortezomib (Bort, 100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MG132 (10 µM) or DMSO vehicle for 1 hour prior to treatment with soluble control antibody or anti-IgM for 6 hours. Expression of PDCD4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HSC70 was 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zed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y immunoblotting. </a:t>
            </a:r>
            <a:r>
              <a:rPr lang="en-GB" sz="1200" i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immunoblots blot.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Quantitation showing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 (±range) PDCD4 expression derived from 2 independent experiments with values for anti-IgM/DMSO-treated cells set to 1.0.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BB73125F-64B2-4FF2-B9BC-E5F7ABF0A5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6570" t="37668" r="25797" b="13177"/>
          <a:stretch/>
        </p:blipFill>
        <p:spPr>
          <a:xfrm>
            <a:off x="889861" y="1369970"/>
            <a:ext cx="2238191" cy="22395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817D196-7105-4C6B-9656-5A260F71170B}"/>
              </a:ext>
            </a:extLst>
          </p:cNvPr>
          <p:cNvSpPr txBox="1"/>
          <p:nvPr/>
        </p:nvSpPr>
        <p:spPr>
          <a:xfrm>
            <a:off x="566011" y="9575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D69955-EB48-443F-B436-08C95BC493D8}"/>
              </a:ext>
            </a:extLst>
          </p:cNvPr>
          <p:cNvSpPr txBox="1"/>
          <p:nvPr/>
        </p:nvSpPr>
        <p:spPr>
          <a:xfrm>
            <a:off x="3232419" y="9575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869767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202A350-7ED4-4FB3-AFE1-EA2D455951E1}"/>
              </a:ext>
            </a:extLst>
          </p:cNvPr>
          <p:cNvSpPr txBox="1"/>
          <p:nvPr/>
        </p:nvSpPr>
        <p:spPr>
          <a:xfrm>
            <a:off x="332090" y="6919388"/>
            <a:ext cx="6193820" cy="2123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3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DCD4 regulation in RL cells. RL cells were pre-treated with bortezomib (100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MG132 (10 µM) or DMSO for 1 hour, and then treated with soluble control antibody or anti-IgM for 4 hours. Expression of PDCD4 and HSC70 was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zed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immunoblotting. </a:t>
            </a:r>
            <a:r>
              <a:rPr lang="en-GB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Representative immunoblots showing uncropped images for Figure 5 of the main manuscript and with full data for control antibody-treated cells. The vertical line indicates an irrelevant lane. </a:t>
            </a:r>
            <a:r>
              <a:rPr lang="en-GB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Quantitation showing effect of inhibitors in cells treated with control antibody derived from 3-4 independent experiments. We did not attempt to quantify ERK1/2 phosphorylation due to the very low signal present in unstimulated cells. </a:t>
            </a:r>
            <a:r>
              <a:rPr lang="en-GB" sz="12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s show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s (±SD) with results for DMSO/control antibody-treated cells set to 1.0. The statistical significance of the differences compared to DMSO/control antibody-treated cells is shown (one sample t-tests). </a:t>
            </a:r>
          </a:p>
        </p:txBody>
      </p:sp>
      <p:pic>
        <p:nvPicPr>
          <p:cNvPr id="3" name="Picture 2" descr="Table&#10;&#10;Description automatically generated">
            <a:extLst>
              <a:ext uri="{FF2B5EF4-FFF2-40B4-BE49-F238E27FC236}">
                <a16:creationId xmlns:a16="http://schemas.microsoft.com/office/drawing/2014/main" id="{87ED7910-B718-4217-870C-D3E361C767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99" t="4548" r="49080" b="33230"/>
          <a:stretch/>
        </p:blipFill>
        <p:spPr>
          <a:xfrm>
            <a:off x="789453" y="188259"/>
            <a:ext cx="4044649" cy="3352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CE23BB2-73F7-438C-9B89-4C7AC1704973}"/>
              </a:ext>
            </a:extLst>
          </p:cNvPr>
          <p:cNvSpPr txBox="1"/>
          <p:nvPr/>
        </p:nvSpPr>
        <p:spPr>
          <a:xfrm>
            <a:off x="306538" y="18825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E1C4035-A7EB-4351-A38B-36583E4B9BB5}"/>
              </a:ext>
            </a:extLst>
          </p:cNvPr>
          <p:cNvSpPr txBox="1"/>
          <p:nvPr/>
        </p:nvSpPr>
        <p:spPr>
          <a:xfrm>
            <a:off x="306538" y="37491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E325BF53-E6A6-402C-9417-9A9C4D0A27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1750789"/>
              </p:ext>
            </p:extLst>
          </p:nvPr>
        </p:nvGraphicFramePr>
        <p:xfrm>
          <a:off x="671910" y="3799608"/>
          <a:ext cx="1782988" cy="2912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392021" imgH="3907671" progId="Prism9.Document">
                  <p:embed/>
                </p:oleObj>
              </mc:Choice>
              <mc:Fallback>
                <p:oleObj name="Prism 9" r:id="rId3" imgW="2392021" imgH="3907671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E325BF53-E6A6-402C-9417-9A9C4D0A27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1910" y="3799608"/>
                        <a:ext cx="1782988" cy="2912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8605881E-59F7-4F65-BB3A-02A87FD203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1175157"/>
              </p:ext>
            </p:extLst>
          </p:nvPr>
        </p:nvGraphicFramePr>
        <p:xfrm>
          <a:off x="2503399" y="4091689"/>
          <a:ext cx="1609067" cy="2612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158653" imgH="3505019" progId="Prism9.Document">
                  <p:embed/>
                </p:oleObj>
              </mc:Choice>
              <mc:Fallback>
                <p:oleObj name="Prism 9" r:id="rId5" imgW="2158653" imgH="3505019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8605881E-59F7-4F65-BB3A-02A87FD203E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03399" y="4091689"/>
                        <a:ext cx="1609067" cy="2612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B1504B0D-5123-47BA-AE59-863AFC4291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1678356"/>
              </p:ext>
            </p:extLst>
          </p:nvPr>
        </p:nvGraphicFramePr>
        <p:xfrm>
          <a:off x="4160967" y="3965418"/>
          <a:ext cx="1704902" cy="27389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286862" imgH="3674292" progId="Prism9.Document">
                  <p:embed/>
                </p:oleObj>
              </mc:Choice>
              <mc:Fallback>
                <p:oleObj name="Prism 9" r:id="rId7" imgW="2286862" imgH="3674292" progId="Prism9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B1504B0D-5123-47BA-AE59-863AFC4291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60967" y="3965418"/>
                        <a:ext cx="1704902" cy="27389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20635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C2CEDF0-DFCA-4930-BE2E-22B693EAEE61}"/>
              </a:ext>
            </a:extLst>
          </p:cNvPr>
          <p:cNvSpPr txBox="1"/>
          <p:nvPr/>
        </p:nvSpPr>
        <p:spPr>
          <a:xfrm>
            <a:off x="321280" y="4164588"/>
            <a:ext cx="61938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4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of combined kinase inhibition on anti-IgM-induced PDCD4 down-regulation in sample 780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hows data for sample 780 from Fig. 7 of the main text.</a:t>
            </a:r>
            <a:endParaRPr lang="en-GB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C963493-C6E2-4DCC-BF8F-DACCF208C4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5791293"/>
              </p:ext>
            </p:extLst>
          </p:nvPr>
        </p:nvGraphicFramePr>
        <p:xfrm>
          <a:off x="2142010" y="848401"/>
          <a:ext cx="1960544" cy="31441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556603" imgH="4098193" progId="Prism9.Document">
                  <p:embed/>
                </p:oleObj>
              </mc:Choice>
              <mc:Fallback>
                <p:oleObj name="Prism 9" r:id="rId2" imgW="2556603" imgH="409819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C963493-C6E2-4DCC-BF8F-DACCF208C4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42010" y="848401"/>
                        <a:ext cx="1960544" cy="31441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103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54</TotalTime>
  <Words>746</Words>
  <Application>Microsoft Office PowerPoint</Application>
  <PresentationFormat>Custom</PresentationFormat>
  <Paragraphs>143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son Yeomans</dc:creator>
  <cp:lastModifiedBy>Graham Packham</cp:lastModifiedBy>
  <cp:revision>62</cp:revision>
  <cp:lastPrinted>2022-01-29T11:00:36Z</cp:lastPrinted>
  <dcterms:created xsi:type="dcterms:W3CDTF">2021-01-27T09:24:36Z</dcterms:created>
  <dcterms:modified xsi:type="dcterms:W3CDTF">2022-03-09T15:08:28Z</dcterms:modified>
</cp:coreProperties>
</file>